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F6C2E1-D324-4A48-BB4D-E9D97A29FE80}" v="9" dt="2021-07-30T14:17:47.88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449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opher Sjöwall" userId="19161b2c-e6b5-421c-acee-44f8d60d4e02" providerId="ADAL" clId="{3EF6C2E1-D324-4A48-BB4D-E9D97A29FE80}"/>
    <pc:docChg chg="undo custSel modSld">
      <pc:chgData name="Christopher Sjöwall" userId="19161b2c-e6b5-421c-acee-44f8d60d4e02" providerId="ADAL" clId="{3EF6C2E1-D324-4A48-BB4D-E9D97A29FE80}" dt="2021-07-30T14:18:01.928" v="428" actId="1035"/>
      <pc:docMkLst>
        <pc:docMk/>
      </pc:docMkLst>
      <pc:sldChg chg="addSp delSp modSp mod">
        <pc:chgData name="Christopher Sjöwall" userId="19161b2c-e6b5-421c-acee-44f8d60d4e02" providerId="ADAL" clId="{3EF6C2E1-D324-4A48-BB4D-E9D97A29FE80}" dt="2021-07-30T14:18:01.928" v="428" actId="1035"/>
        <pc:sldMkLst>
          <pc:docMk/>
          <pc:sldMk cId="2087246386" sldId="256"/>
        </pc:sldMkLst>
        <pc:spChg chg="mod">
          <ac:chgData name="Christopher Sjöwall" userId="19161b2c-e6b5-421c-acee-44f8d60d4e02" providerId="ADAL" clId="{3EF6C2E1-D324-4A48-BB4D-E9D97A29FE80}" dt="2021-07-30T14:11:19.135" v="352" actId="6549"/>
          <ac:spMkLst>
            <pc:docMk/>
            <pc:sldMk cId="2087246386" sldId="256"/>
            <ac:spMk id="16" creationId="{8F9A17E9-A84A-4B61-AAF9-5D3A97EBE2F0}"/>
          </ac:spMkLst>
        </pc:spChg>
        <pc:spChg chg="mod">
          <ac:chgData name="Christopher Sjöwall" userId="19161b2c-e6b5-421c-acee-44f8d60d4e02" providerId="ADAL" clId="{3EF6C2E1-D324-4A48-BB4D-E9D97A29FE80}" dt="2021-07-30T14:14:28.404" v="395" actId="164"/>
          <ac:spMkLst>
            <pc:docMk/>
            <pc:sldMk cId="2087246386" sldId="256"/>
            <ac:spMk id="23" creationId="{69B227AC-6082-41B4-9164-C76F4F2B1593}"/>
          </ac:spMkLst>
        </pc:spChg>
        <pc:spChg chg="mod">
          <ac:chgData name="Christopher Sjöwall" userId="19161b2c-e6b5-421c-acee-44f8d60d4e02" providerId="ADAL" clId="{3EF6C2E1-D324-4A48-BB4D-E9D97A29FE80}" dt="2021-07-30T14:14:28.404" v="395" actId="164"/>
          <ac:spMkLst>
            <pc:docMk/>
            <pc:sldMk cId="2087246386" sldId="256"/>
            <ac:spMk id="25" creationId="{116EF6C9-3AC6-4158-B2AA-739606DCDD52}"/>
          </ac:spMkLst>
        </pc:spChg>
        <pc:spChg chg="mod topLvl">
          <ac:chgData name="Christopher Sjöwall" userId="19161b2c-e6b5-421c-acee-44f8d60d4e02" providerId="ADAL" clId="{3EF6C2E1-D324-4A48-BB4D-E9D97A29FE80}" dt="2021-07-30T14:17:47.881" v="425" actId="164"/>
          <ac:spMkLst>
            <pc:docMk/>
            <pc:sldMk cId="2087246386" sldId="256"/>
            <ac:spMk id="28" creationId="{36E35B2F-AD0B-4D05-8F93-7A86AE1FF9AC}"/>
          </ac:spMkLst>
        </pc:spChg>
        <pc:spChg chg="mod topLvl">
          <ac:chgData name="Christopher Sjöwall" userId="19161b2c-e6b5-421c-acee-44f8d60d4e02" providerId="ADAL" clId="{3EF6C2E1-D324-4A48-BB4D-E9D97A29FE80}" dt="2021-07-30T14:17:47.881" v="425" actId="164"/>
          <ac:spMkLst>
            <pc:docMk/>
            <pc:sldMk cId="2087246386" sldId="256"/>
            <ac:spMk id="29" creationId="{32AAB2ED-A1BE-45A9-80D1-EB9F645A1D81}"/>
          </ac:spMkLst>
        </pc:spChg>
        <pc:spChg chg="add mod">
          <ac:chgData name="Christopher Sjöwall" userId="19161b2c-e6b5-421c-acee-44f8d60d4e02" providerId="ADAL" clId="{3EF6C2E1-D324-4A48-BB4D-E9D97A29FE80}" dt="2021-07-30T14:15:56.106" v="421" actId="6549"/>
          <ac:spMkLst>
            <pc:docMk/>
            <pc:sldMk cId="2087246386" sldId="256"/>
            <ac:spMk id="32" creationId="{204AD3BD-8A3E-427F-BB27-B01CFAA752E4}"/>
          </ac:spMkLst>
        </pc:spChg>
        <pc:spChg chg="add mod">
          <ac:chgData name="Christopher Sjöwall" userId="19161b2c-e6b5-421c-acee-44f8d60d4e02" providerId="ADAL" clId="{3EF6C2E1-D324-4A48-BB4D-E9D97A29FE80}" dt="2021-07-30T14:12:52.632" v="357" actId="164"/>
          <ac:spMkLst>
            <pc:docMk/>
            <pc:sldMk cId="2087246386" sldId="256"/>
            <ac:spMk id="36" creationId="{D7EE4A71-3583-4F13-95E8-DBD4C8FC759D}"/>
          </ac:spMkLst>
        </pc:spChg>
        <pc:spChg chg="add mod">
          <ac:chgData name="Christopher Sjöwall" userId="19161b2c-e6b5-421c-acee-44f8d60d4e02" providerId="ADAL" clId="{3EF6C2E1-D324-4A48-BB4D-E9D97A29FE80}" dt="2021-07-30T14:12:52.632" v="357" actId="164"/>
          <ac:spMkLst>
            <pc:docMk/>
            <pc:sldMk cId="2087246386" sldId="256"/>
            <ac:spMk id="37" creationId="{ED4E0A90-3A98-4D0D-9B4A-76CC495432E1}"/>
          </ac:spMkLst>
        </pc:spChg>
        <pc:grpChg chg="del ord">
          <ac:chgData name="Christopher Sjöwall" userId="19161b2c-e6b5-421c-acee-44f8d60d4e02" providerId="ADAL" clId="{3EF6C2E1-D324-4A48-BB4D-E9D97A29FE80}" dt="2021-07-30T14:13:50.404" v="390" actId="165"/>
          <ac:grpSpMkLst>
            <pc:docMk/>
            <pc:sldMk cId="2087246386" sldId="256"/>
            <ac:grpSpMk id="17" creationId="{D3326D52-7282-4132-A96D-7700F261CDC6}"/>
          </ac:grpSpMkLst>
        </pc:grpChg>
        <pc:grpChg chg="del mod ord topLvl">
          <ac:chgData name="Christopher Sjöwall" userId="19161b2c-e6b5-421c-acee-44f8d60d4e02" providerId="ADAL" clId="{3EF6C2E1-D324-4A48-BB4D-E9D97A29FE80}" dt="2021-07-30T14:17:09.365" v="423" actId="165"/>
          <ac:grpSpMkLst>
            <pc:docMk/>
            <pc:sldMk cId="2087246386" sldId="256"/>
            <ac:grpSpMk id="21" creationId="{4C26ED50-93E3-40B3-9D6B-E0724C008750}"/>
          </ac:grpSpMkLst>
        </pc:grpChg>
        <pc:grpChg chg="add mod">
          <ac:chgData name="Christopher Sjöwall" userId="19161b2c-e6b5-421c-acee-44f8d60d4e02" providerId="ADAL" clId="{3EF6C2E1-D324-4A48-BB4D-E9D97A29FE80}" dt="2021-07-30T14:12:52.632" v="357" actId="164"/>
          <ac:grpSpMkLst>
            <pc:docMk/>
            <pc:sldMk cId="2087246386" sldId="256"/>
            <ac:grpSpMk id="33" creationId="{89ED577F-32D4-45AF-A29E-B4E91DD7EC72}"/>
          </ac:grpSpMkLst>
        </pc:grpChg>
        <pc:grpChg chg="add mod">
          <ac:chgData name="Christopher Sjöwall" userId="19161b2c-e6b5-421c-acee-44f8d60d4e02" providerId="ADAL" clId="{3EF6C2E1-D324-4A48-BB4D-E9D97A29FE80}" dt="2021-07-30T14:12:56.527" v="370" actId="1036"/>
          <ac:grpSpMkLst>
            <pc:docMk/>
            <pc:sldMk cId="2087246386" sldId="256"/>
            <ac:grpSpMk id="38" creationId="{ED2CA72E-9762-4793-A1CD-26CE9B06FFA3}"/>
          </ac:grpSpMkLst>
        </pc:grpChg>
        <pc:grpChg chg="add del mod ord">
          <ac:chgData name="Christopher Sjöwall" userId="19161b2c-e6b5-421c-acee-44f8d60d4e02" providerId="ADAL" clId="{3EF6C2E1-D324-4A48-BB4D-E9D97A29FE80}" dt="2021-07-30T14:17:03.360" v="422" actId="165"/>
          <ac:grpSpMkLst>
            <pc:docMk/>
            <pc:sldMk cId="2087246386" sldId="256"/>
            <ac:grpSpMk id="39" creationId="{BD881390-E0CB-461C-87A2-389366517786}"/>
          </ac:grpSpMkLst>
        </pc:grpChg>
        <pc:grpChg chg="add mod">
          <ac:chgData name="Christopher Sjöwall" userId="19161b2c-e6b5-421c-acee-44f8d60d4e02" providerId="ADAL" clId="{3EF6C2E1-D324-4A48-BB4D-E9D97A29FE80}" dt="2021-07-30T14:14:30.744" v="399" actId="1035"/>
          <ac:grpSpMkLst>
            <pc:docMk/>
            <pc:sldMk cId="2087246386" sldId="256"/>
            <ac:grpSpMk id="40" creationId="{85B2EFAD-6A98-462D-8419-3EE58B72A9E1}"/>
          </ac:grpSpMkLst>
        </pc:grpChg>
        <pc:grpChg chg="add mod">
          <ac:chgData name="Christopher Sjöwall" userId="19161b2c-e6b5-421c-acee-44f8d60d4e02" providerId="ADAL" clId="{3EF6C2E1-D324-4A48-BB4D-E9D97A29FE80}" dt="2021-07-30T14:18:01.928" v="428" actId="1035"/>
          <ac:grpSpMkLst>
            <pc:docMk/>
            <pc:sldMk cId="2087246386" sldId="256"/>
            <ac:grpSpMk id="41" creationId="{CE26A2F6-D9DB-44C9-90EC-C6C14F84F9EF}"/>
          </ac:grpSpMkLst>
        </pc:grpChg>
        <pc:picChg chg="mod topLvl">
          <ac:chgData name="Christopher Sjöwall" userId="19161b2c-e6b5-421c-acee-44f8d60d4e02" providerId="ADAL" clId="{3EF6C2E1-D324-4A48-BB4D-E9D97A29FE80}" dt="2021-07-30T14:14:28.404" v="395" actId="164"/>
          <ac:picMkLst>
            <pc:docMk/>
            <pc:sldMk cId="2087246386" sldId="256"/>
            <ac:picMk id="5" creationId="{8A52A376-0E5E-466F-B943-0AB37E40FA05}"/>
          </ac:picMkLst>
        </pc:picChg>
        <pc:picChg chg="mod ord topLvl">
          <ac:chgData name="Christopher Sjöwall" userId="19161b2c-e6b5-421c-acee-44f8d60d4e02" providerId="ADAL" clId="{3EF6C2E1-D324-4A48-BB4D-E9D97A29FE80}" dt="2021-07-30T14:14:28.404" v="395" actId="164"/>
          <ac:picMkLst>
            <pc:docMk/>
            <pc:sldMk cId="2087246386" sldId="256"/>
            <ac:picMk id="7" creationId="{001026C0-2501-4D5B-9733-BED2B1BBE62E}"/>
          </ac:picMkLst>
        </pc:picChg>
        <pc:picChg chg="mod topLvl modCrop">
          <ac:chgData name="Christopher Sjöwall" userId="19161b2c-e6b5-421c-acee-44f8d60d4e02" providerId="ADAL" clId="{3EF6C2E1-D324-4A48-BB4D-E9D97A29FE80}" dt="2021-07-30T14:17:47.881" v="425" actId="164"/>
          <ac:picMkLst>
            <pc:docMk/>
            <pc:sldMk cId="2087246386" sldId="256"/>
            <ac:picMk id="11" creationId="{7BA52D6F-E904-4708-8623-9CEE40C714F7}"/>
          </ac:picMkLst>
        </pc:picChg>
        <pc:picChg chg="mod topLvl">
          <ac:chgData name="Christopher Sjöwall" userId="19161b2c-e6b5-421c-acee-44f8d60d4e02" providerId="ADAL" clId="{3EF6C2E1-D324-4A48-BB4D-E9D97A29FE80}" dt="2021-07-30T14:17:47.881" v="425" actId="164"/>
          <ac:picMkLst>
            <pc:docMk/>
            <pc:sldMk cId="2087246386" sldId="256"/>
            <ac:picMk id="20" creationId="{5A839456-E72F-4587-8E16-A7D398C45F80}"/>
          </ac:picMkLst>
        </pc:picChg>
        <pc:picChg chg="mod">
          <ac:chgData name="Christopher Sjöwall" userId="19161b2c-e6b5-421c-acee-44f8d60d4e02" providerId="ADAL" clId="{3EF6C2E1-D324-4A48-BB4D-E9D97A29FE80}" dt="2021-07-30T14:12:48.500" v="356" actId="571"/>
          <ac:picMkLst>
            <pc:docMk/>
            <pc:sldMk cId="2087246386" sldId="256"/>
            <ac:picMk id="34" creationId="{445EA204-3C1D-4D16-9040-DB985A858CA2}"/>
          </ac:picMkLst>
        </pc:picChg>
        <pc:picChg chg="mod">
          <ac:chgData name="Christopher Sjöwall" userId="19161b2c-e6b5-421c-acee-44f8d60d4e02" providerId="ADAL" clId="{3EF6C2E1-D324-4A48-BB4D-E9D97A29FE80}" dt="2021-07-30T14:12:48.500" v="356" actId="571"/>
          <ac:picMkLst>
            <pc:docMk/>
            <pc:sldMk cId="2087246386" sldId="256"/>
            <ac:picMk id="35" creationId="{F575AF91-D0D0-49B6-A2A0-06BB14B9C78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08103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15267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23749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2654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06275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8823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80662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45088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56229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1089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98722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13371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ruta 15">
            <a:extLst>
              <a:ext uri="{FF2B5EF4-FFF2-40B4-BE49-F238E27FC236}">
                <a16:creationId xmlns:a16="http://schemas.microsoft.com/office/drawing/2014/main" id="{8F9A17E9-A84A-4B61-AAF9-5D3A97EBE2F0}"/>
              </a:ext>
            </a:extLst>
          </p:cNvPr>
          <p:cNvSpPr txBox="1"/>
          <p:nvPr/>
        </p:nvSpPr>
        <p:spPr>
          <a:xfrm>
            <a:off x="474920" y="219740"/>
            <a:ext cx="364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Supplementary Figure 1</a:t>
            </a:r>
            <a:endParaRPr lang="sv-SE" dirty="0"/>
          </a:p>
        </p:txBody>
      </p:sp>
      <p:grpSp>
        <p:nvGrpSpPr>
          <p:cNvPr id="22" name="Grupp 21">
            <a:extLst>
              <a:ext uri="{FF2B5EF4-FFF2-40B4-BE49-F238E27FC236}">
                <a16:creationId xmlns:a16="http://schemas.microsoft.com/office/drawing/2014/main" id="{4A872431-C7B0-41DD-ACD3-0D2AB550F82F}"/>
              </a:ext>
            </a:extLst>
          </p:cNvPr>
          <p:cNvGrpSpPr/>
          <p:nvPr/>
        </p:nvGrpSpPr>
        <p:grpSpPr>
          <a:xfrm>
            <a:off x="552159" y="6700073"/>
            <a:ext cx="5899408" cy="3242321"/>
            <a:chOff x="760705" y="6539653"/>
            <a:chExt cx="5899408" cy="3242321"/>
          </a:xfrm>
        </p:grpSpPr>
        <p:pic>
          <p:nvPicPr>
            <p:cNvPr id="13" name="Bildobjekt 12">
              <a:extLst>
                <a:ext uri="{FF2B5EF4-FFF2-40B4-BE49-F238E27FC236}">
                  <a16:creationId xmlns:a16="http://schemas.microsoft.com/office/drawing/2014/main" id="{C7C4BF77-5EFD-4A7F-AFA7-5D889DBC85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0705" y="6539653"/>
              <a:ext cx="2682939" cy="3242321"/>
            </a:xfrm>
            <a:prstGeom prst="rect">
              <a:avLst/>
            </a:prstGeom>
          </p:spPr>
        </p:pic>
        <p:pic>
          <p:nvPicPr>
            <p:cNvPr id="15" name="Bildobjekt 14">
              <a:extLst>
                <a:ext uri="{FF2B5EF4-FFF2-40B4-BE49-F238E27FC236}">
                  <a16:creationId xmlns:a16="http://schemas.microsoft.com/office/drawing/2014/main" id="{5270C72D-887C-46B6-B6FE-D05970B8C95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79532" y="6605125"/>
              <a:ext cx="2780581" cy="3060000"/>
            </a:xfrm>
            <a:prstGeom prst="rect">
              <a:avLst/>
            </a:prstGeom>
          </p:spPr>
        </p:pic>
      </p:grpSp>
      <p:grpSp>
        <p:nvGrpSpPr>
          <p:cNvPr id="41" name="Grupp 40">
            <a:extLst>
              <a:ext uri="{FF2B5EF4-FFF2-40B4-BE49-F238E27FC236}">
                <a16:creationId xmlns:a16="http://schemas.microsoft.com/office/drawing/2014/main" id="{CE26A2F6-D9DB-44C9-90EC-C6C14F84F9EF}"/>
              </a:ext>
            </a:extLst>
          </p:cNvPr>
          <p:cNvGrpSpPr/>
          <p:nvPr/>
        </p:nvGrpSpPr>
        <p:grpSpPr>
          <a:xfrm>
            <a:off x="560265" y="3973006"/>
            <a:ext cx="5737470" cy="2880000"/>
            <a:chOff x="560265" y="3996859"/>
            <a:chExt cx="5737470" cy="2880000"/>
          </a:xfrm>
        </p:grpSpPr>
        <p:pic>
          <p:nvPicPr>
            <p:cNvPr id="11" name="Bildobjekt 10">
              <a:extLst>
                <a:ext uri="{FF2B5EF4-FFF2-40B4-BE49-F238E27FC236}">
                  <a16:creationId xmlns:a16="http://schemas.microsoft.com/office/drawing/2014/main" id="{7BA52D6F-E904-4708-8623-9CEE40C714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641"/>
            <a:stretch/>
          </p:blipFill>
          <p:spPr>
            <a:xfrm>
              <a:off x="3660229" y="4041562"/>
              <a:ext cx="2637506" cy="2795574"/>
            </a:xfrm>
            <a:prstGeom prst="rect">
              <a:avLst/>
            </a:prstGeom>
          </p:spPr>
        </p:pic>
        <p:pic>
          <p:nvPicPr>
            <p:cNvPr id="20" name="Bildobjekt 19">
              <a:extLst>
                <a:ext uri="{FF2B5EF4-FFF2-40B4-BE49-F238E27FC236}">
                  <a16:creationId xmlns:a16="http://schemas.microsoft.com/office/drawing/2014/main" id="{5A839456-E72F-4587-8E16-A7D398C45F8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663" y="3996859"/>
              <a:ext cx="2480148" cy="2880000"/>
            </a:xfrm>
            <a:prstGeom prst="rect">
              <a:avLst/>
            </a:prstGeom>
          </p:spPr>
        </p:pic>
        <p:sp>
          <p:nvSpPr>
            <p:cNvPr id="28" name="textruta 27">
              <a:extLst>
                <a:ext uri="{FF2B5EF4-FFF2-40B4-BE49-F238E27FC236}">
                  <a16:creationId xmlns:a16="http://schemas.microsoft.com/office/drawing/2014/main" id="{36E35B2F-AD0B-4D05-8F93-7A86AE1FF9AC}"/>
                </a:ext>
              </a:extLst>
            </p:cNvPr>
            <p:cNvSpPr txBox="1"/>
            <p:nvPr/>
          </p:nvSpPr>
          <p:spPr>
            <a:xfrm>
              <a:off x="560265" y="4073998"/>
              <a:ext cx="415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b="1" dirty="0">
                  <a:effectLst/>
                  <a:ea typeface="Calibri" panose="020F0502020204030204" pitchFamily="34" charset="0"/>
                </a:rPr>
                <a:t>C)</a:t>
              </a:r>
              <a:endParaRPr lang="sv-SE" dirty="0"/>
            </a:p>
          </p:txBody>
        </p:sp>
        <p:sp>
          <p:nvSpPr>
            <p:cNvPr id="29" name="textruta 28">
              <a:extLst>
                <a:ext uri="{FF2B5EF4-FFF2-40B4-BE49-F238E27FC236}">
                  <a16:creationId xmlns:a16="http://schemas.microsoft.com/office/drawing/2014/main" id="{32AAB2ED-A1BE-45A9-80D1-EB9F645A1D81}"/>
                </a:ext>
              </a:extLst>
            </p:cNvPr>
            <p:cNvSpPr txBox="1"/>
            <p:nvPr/>
          </p:nvSpPr>
          <p:spPr>
            <a:xfrm>
              <a:off x="3593025" y="4080094"/>
              <a:ext cx="415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b="1" dirty="0">
                  <a:effectLst/>
                  <a:ea typeface="Calibri" panose="020F0502020204030204" pitchFamily="34" charset="0"/>
                </a:rPr>
                <a:t>D)</a:t>
              </a:r>
              <a:endParaRPr lang="sv-SE" dirty="0"/>
            </a:p>
          </p:txBody>
        </p:sp>
      </p:grpSp>
      <p:grpSp>
        <p:nvGrpSpPr>
          <p:cNvPr id="40" name="Grupp 39">
            <a:extLst>
              <a:ext uri="{FF2B5EF4-FFF2-40B4-BE49-F238E27FC236}">
                <a16:creationId xmlns:a16="http://schemas.microsoft.com/office/drawing/2014/main" id="{85B2EFAD-6A98-462D-8419-3EE58B72A9E1}"/>
              </a:ext>
            </a:extLst>
          </p:cNvPr>
          <p:cNvGrpSpPr/>
          <p:nvPr/>
        </p:nvGrpSpPr>
        <p:grpSpPr>
          <a:xfrm>
            <a:off x="524311" y="785317"/>
            <a:ext cx="5438028" cy="3123792"/>
            <a:chOff x="524311" y="817121"/>
            <a:chExt cx="5438028" cy="3123792"/>
          </a:xfrm>
        </p:grpSpPr>
        <p:pic>
          <p:nvPicPr>
            <p:cNvPr id="5" name="Bildobjekt 4">
              <a:extLst>
                <a:ext uri="{FF2B5EF4-FFF2-40B4-BE49-F238E27FC236}">
                  <a16:creationId xmlns:a16="http://schemas.microsoft.com/office/drawing/2014/main" id="{8A52A376-0E5E-466F-B943-0AB37E40FA0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311" y="880913"/>
              <a:ext cx="2482851" cy="3060000"/>
            </a:xfrm>
            <a:prstGeom prst="rect">
              <a:avLst/>
            </a:prstGeom>
          </p:spPr>
        </p:pic>
        <p:pic>
          <p:nvPicPr>
            <p:cNvPr id="7" name="Bildobjekt 6">
              <a:extLst>
                <a:ext uri="{FF2B5EF4-FFF2-40B4-BE49-F238E27FC236}">
                  <a16:creationId xmlns:a16="http://schemas.microsoft.com/office/drawing/2014/main" id="{001026C0-2501-4D5B-9733-BED2B1BBE62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4921" y="817121"/>
              <a:ext cx="2387418" cy="3060000"/>
            </a:xfrm>
            <a:prstGeom prst="rect">
              <a:avLst/>
            </a:prstGeom>
          </p:spPr>
        </p:pic>
        <p:sp>
          <p:nvSpPr>
            <p:cNvPr id="23" name="textruta 22">
              <a:extLst>
                <a:ext uri="{FF2B5EF4-FFF2-40B4-BE49-F238E27FC236}">
                  <a16:creationId xmlns:a16="http://schemas.microsoft.com/office/drawing/2014/main" id="{69B227AC-6082-41B4-9164-C76F4F2B1593}"/>
                </a:ext>
              </a:extLst>
            </p:cNvPr>
            <p:cNvSpPr txBox="1"/>
            <p:nvPr/>
          </p:nvSpPr>
          <p:spPr>
            <a:xfrm>
              <a:off x="554169" y="911636"/>
              <a:ext cx="415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b="1" dirty="0">
                  <a:effectLst/>
                  <a:ea typeface="Calibri" panose="020F0502020204030204" pitchFamily="34" charset="0"/>
                </a:rPr>
                <a:t>A)</a:t>
              </a:r>
              <a:endParaRPr lang="sv-SE" dirty="0"/>
            </a:p>
          </p:txBody>
        </p:sp>
        <p:sp>
          <p:nvSpPr>
            <p:cNvPr id="25" name="textruta 24">
              <a:extLst>
                <a:ext uri="{FF2B5EF4-FFF2-40B4-BE49-F238E27FC236}">
                  <a16:creationId xmlns:a16="http://schemas.microsoft.com/office/drawing/2014/main" id="{116EF6C9-3AC6-4158-B2AA-739606DCDD52}"/>
                </a:ext>
              </a:extLst>
            </p:cNvPr>
            <p:cNvSpPr txBox="1"/>
            <p:nvPr/>
          </p:nvSpPr>
          <p:spPr>
            <a:xfrm>
              <a:off x="3586929" y="917732"/>
              <a:ext cx="415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b="1" dirty="0">
                  <a:effectLst/>
                  <a:ea typeface="Calibri" panose="020F0502020204030204" pitchFamily="34" charset="0"/>
                </a:rPr>
                <a:t>B)</a:t>
              </a:r>
              <a:endParaRPr lang="sv-SE" dirty="0"/>
            </a:p>
          </p:txBody>
        </p:sp>
      </p:grpSp>
      <p:sp>
        <p:nvSpPr>
          <p:cNvPr id="30" name="textruta 29">
            <a:extLst>
              <a:ext uri="{FF2B5EF4-FFF2-40B4-BE49-F238E27FC236}">
                <a16:creationId xmlns:a16="http://schemas.microsoft.com/office/drawing/2014/main" id="{687659C7-F731-45D5-BBC8-051FB8B62804}"/>
              </a:ext>
            </a:extLst>
          </p:cNvPr>
          <p:cNvSpPr txBox="1"/>
          <p:nvPr/>
        </p:nvSpPr>
        <p:spPr>
          <a:xfrm>
            <a:off x="557217" y="6830852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E)</a:t>
            </a:r>
            <a:endParaRPr lang="sv-SE" dirty="0"/>
          </a:p>
        </p:txBody>
      </p:sp>
      <p:sp>
        <p:nvSpPr>
          <p:cNvPr id="31" name="textruta 30">
            <a:extLst>
              <a:ext uri="{FF2B5EF4-FFF2-40B4-BE49-F238E27FC236}">
                <a16:creationId xmlns:a16="http://schemas.microsoft.com/office/drawing/2014/main" id="{190392FF-944A-490B-9F3A-382C2A56EB75}"/>
              </a:ext>
            </a:extLst>
          </p:cNvPr>
          <p:cNvSpPr txBox="1"/>
          <p:nvPr/>
        </p:nvSpPr>
        <p:spPr>
          <a:xfrm>
            <a:off x="3589977" y="6836948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F)</a:t>
            </a:r>
            <a:endParaRPr lang="sv-SE" dirty="0"/>
          </a:p>
        </p:txBody>
      </p:sp>
      <p:sp>
        <p:nvSpPr>
          <p:cNvPr id="32" name="textruta 31">
            <a:extLst>
              <a:ext uri="{FF2B5EF4-FFF2-40B4-BE49-F238E27FC236}">
                <a16:creationId xmlns:a16="http://schemas.microsoft.com/office/drawing/2014/main" id="{204AD3BD-8A3E-427F-BB27-B01CFAA752E4}"/>
              </a:ext>
            </a:extLst>
          </p:cNvPr>
          <p:cNvSpPr txBox="1"/>
          <p:nvPr/>
        </p:nvSpPr>
        <p:spPr>
          <a:xfrm>
            <a:off x="318978" y="10179184"/>
            <a:ext cx="633700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ired serum samples from 3 SLE patients with strong IgA and/or IgM SARS-CoV-2 reactivity as judged by our in-house ELISA were used for blocking experiments. The sera were preincubated 1h at 37°C with increasing concentrations (0.1, 1 and 10 µg/L) of SARS-CoV-2 S1-spike protein, or with irrelevant antigens: influenza A or bovine serum albumin (BSA). A dose-dependent reduction in antibody binding was achieved for both IgA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–D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IgM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–F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following preincubation with S1-spike protein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" name="Grupp 37">
            <a:extLst>
              <a:ext uri="{FF2B5EF4-FFF2-40B4-BE49-F238E27FC236}">
                <a16:creationId xmlns:a16="http://schemas.microsoft.com/office/drawing/2014/main" id="{ED2CA72E-9762-4793-A1CD-26CE9B06FFA3}"/>
              </a:ext>
            </a:extLst>
          </p:cNvPr>
          <p:cNvGrpSpPr/>
          <p:nvPr/>
        </p:nvGrpSpPr>
        <p:grpSpPr>
          <a:xfrm>
            <a:off x="554169" y="6797082"/>
            <a:ext cx="5899408" cy="3242321"/>
            <a:chOff x="554169" y="6693719"/>
            <a:chExt cx="5899408" cy="3242321"/>
          </a:xfrm>
        </p:grpSpPr>
        <p:grpSp>
          <p:nvGrpSpPr>
            <p:cNvPr id="33" name="Grupp 32">
              <a:extLst>
                <a:ext uri="{FF2B5EF4-FFF2-40B4-BE49-F238E27FC236}">
                  <a16:creationId xmlns:a16="http://schemas.microsoft.com/office/drawing/2014/main" id="{89ED577F-32D4-45AF-A29E-B4E91DD7EC72}"/>
                </a:ext>
              </a:extLst>
            </p:cNvPr>
            <p:cNvGrpSpPr/>
            <p:nvPr/>
          </p:nvGrpSpPr>
          <p:grpSpPr>
            <a:xfrm>
              <a:off x="554169" y="6693719"/>
              <a:ext cx="5899408" cy="3242321"/>
              <a:chOff x="760705" y="6539653"/>
              <a:chExt cx="5899408" cy="3242321"/>
            </a:xfrm>
          </p:grpSpPr>
          <p:pic>
            <p:nvPicPr>
              <p:cNvPr id="34" name="Bildobjekt 33">
                <a:extLst>
                  <a:ext uri="{FF2B5EF4-FFF2-40B4-BE49-F238E27FC236}">
                    <a16:creationId xmlns:a16="http://schemas.microsoft.com/office/drawing/2014/main" id="{445EA204-3C1D-4D16-9040-DB985A858C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0705" y="6539653"/>
                <a:ext cx="2682939" cy="3242321"/>
              </a:xfrm>
              <a:prstGeom prst="rect">
                <a:avLst/>
              </a:prstGeom>
            </p:spPr>
          </p:pic>
          <p:pic>
            <p:nvPicPr>
              <p:cNvPr id="35" name="Bildobjekt 34">
                <a:extLst>
                  <a:ext uri="{FF2B5EF4-FFF2-40B4-BE49-F238E27FC236}">
                    <a16:creationId xmlns:a16="http://schemas.microsoft.com/office/drawing/2014/main" id="{F575AF91-D0D0-49B6-A2A0-06BB14B9C7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79532" y="6605125"/>
                <a:ext cx="2780581" cy="3060000"/>
              </a:xfrm>
              <a:prstGeom prst="rect">
                <a:avLst/>
              </a:prstGeom>
            </p:spPr>
          </p:pic>
        </p:grpSp>
        <p:sp>
          <p:nvSpPr>
            <p:cNvPr id="36" name="textruta 35">
              <a:extLst>
                <a:ext uri="{FF2B5EF4-FFF2-40B4-BE49-F238E27FC236}">
                  <a16:creationId xmlns:a16="http://schemas.microsoft.com/office/drawing/2014/main" id="{D7EE4A71-3583-4F13-95E8-DBD4C8FC759D}"/>
                </a:ext>
              </a:extLst>
            </p:cNvPr>
            <p:cNvSpPr txBox="1"/>
            <p:nvPr/>
          </p:nvSpPr>
          <p:spPr>
            <a:xfrm>
              <a:off x="559227" y="6824498"/>
              <a:ext cx="415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b="1" dirty="0">
                  <a:effectLst/>
                  <a:ea typeface="Calibri" panose="020F0502020204030204" pitchFamily="34" charset="0"/>
                </a:rPr>
                <a:t>E)</a:t>
              </a:r>
              <a:endParaRPr lang="sv-SE" dirty="0"/>
            </a:p>
          </p:txBody>
        </p:sp>
        <p:sp>
          <p:nvSpPr>
            <p:cNvPr id="37" name="textruta 36">
              <a:extLst>
                <a:ext uri="{FF2B5EF4-FFF2-40B4-BE49-F238E27FC236}">
                  <a16:creationId xmlns:a16="http://schemas.microsoft.com/office/drawing/2014/main" id="{ED4E0A90-3A98-4D0D-9B4A-76CC495432E1}"/>
                </a:ext>
              </a:extLst>
            </p:cNvPr>
            <p:cNvSpPr txBox="1"/>
            <p:nvPr/>
          </p:nvSpPr>
          <p:spPr>
            <a:xfrm>
              <a:off x="3591987" y="6830594"/>
              <a:ext cx="415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b="1" dirty="0">
                  <a:effectLst/>
                  <a:ea typeface="Calibri" panose="020F0502020204030204" pitchFamily="34" charset="0"/>
                </a:rPr>
                <a:t>F)</a:t>
              </a:r>
              <a:endParaRPr lang="sv-SE" dirty="0"/>
            </a:p>
          </p:txBody>
        </p:sp>
      </p:grpSp>
    </p:spTree>
    <p:extLst>
      <p:ext uri="{BB962C8B-B14F-4D97-AF65-F5344CB8AC3E}">
        <p14:creationId xmlns:p14="http://schemas.microsoft.com/office/powerpoint/2010/main" val="2087246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</TotalTime>
  <Words>107</Words>
  <Application>Microsoft Office PowerPoint</Application>
  <PresentationFormat>Bredbild</PresentationFormat>
  <Paragraphs>10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Christopher Sjöwall</dc:creator>
  <cp:lastModifiedBy>Sjöwall Christoffer</cp:lastModifiedBy>
  <cp:revision>2</cp:revision>
  <dcterms:created xsi:type="dcterms:W3CDTF">2021-07-30T13:34:32Z</dcterms:created>
  <dcterms:modified xsi:type="dcterms:W3CDTF">2021-07-30T19:45:44Z</dcterms:modified>
</cp:coreProperties>
</file>